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6858000" cy="9144000" type="screen4x3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-2491" y="-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4E88D-3508-4E1D-AEB2-3BCC925595AA}" type="datetimeFigureOut">
              <a:rPr lang="es-CL" smtClean="0"/>
              <a:t>10-12-2012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DB91-2051-4505-9B6A-14170241E776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532992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4E88D-3508-4E1D-AEB2-3BCC925595AA}" type="datetimeFigureOut">
              <a:rPr lang="es-CL" smtClean="0"/>
              <a:t>10-12-2012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DB91-2051-4505-9B6A-14170241E776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851736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4E88D-3508-4E1D-AEB2-3BCC925595AA}" type="datetimeFigureOut">
              <a:rPr lang="es-CL" smtClean="0"/>
              <a:t>10-12-2012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DB91-2051-4505-9B6A-14170241E776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804307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4E88D-3508-4E1D-AEB2-3BCC925595AA}" type="datetimeFigureOut">
              <a:rPr lang="es-CL" smtClean="0"/>
              <a:t>10-12-2012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DB91-2051-4505-9B6A-14170241E776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14128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4E88D-3508-4E1D-AEB2-3BCC925595AA}" type="datetimeFigureOut">
              <a:rPr lang="es-CL" smtClean="0"/>
              <a:t>10-12-2012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DB91-2051-4505-9B6A-14170241E776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076081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4E88D-3508-4E1D-AEB2-3BCC925595AA}" type="datetimeFigureOut">
              <a:rPr lang="es-CL" smtClean="0"/>
              <a:t>10-12-2012</a:t>
            </a:fld>
            <a:endParaRPr lang="es-C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DB91-2051-4505-9B6A-14170241E776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785773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4E88D-3508-4E1D-AEB2-3BCC925595AA}" type="datetimeFigureOut">
              <a:rPr lang="es-CL" smtClean="0"/>
              <a:t>10-12-2012</a:t>
            </a:fld>
            <a:endParaRPr lang="es-CL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DB91-2051-4505-9B6A-14170241E776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881545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4E88D-3508-4E1D-AEB2-3BCC925595AA}" type="datetimeFigureOut">
              <a:rPr lang="es-CL" smtClean="0"/>
              <a:t>10-12-2012</a:t>
            </a:fld>
            <a:endParaRPr lang="es-CL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DB91-2051-4505-9B6A-14170241E776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885493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4E88D-3508-4E1D-AEB2-3BCC925595AA}" type="datetimeFigureOut">
              <a:rPr lang="es-CL" smtClean="0"/>
              <a:t>10-12-2012</a:t>
            </a:fld>
            <a:endParaRPr lang="es-CL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DB91-2051-4505-9B6A-14170241E776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703435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4E88D-3508-4E1D-AEB2-3BCC925595AA}" type="datetimeFigureOut">
              <a:rPr lang="es-CL" smtClean="0"/>
              <a:t>10-12-2012</a:t>
            </a:fld>
            <a:endParaRPr lang="es-C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DB91-2051-4505-9B6A-14170241E776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136123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4E88D-3508-4E1D-AEB2-3BCC925595AA}" type="datetimeFigureOut">
              <a:rPr lang="es-CL" smtClean="0"/>
              <a:t>10-12-2012</a:t>
            </a:fld>
            <a:endParaRPr lang="es-C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DB91-2051-4505-9B6A-14170241E776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1453517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D4E88D-3508-4E1D-AEB2-3BCC925595AA}" type="datetimeFigureOut">
              <a:rPr lang="es-CL" smtClean="0"/>
              <a:t>10-12-2012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6EDB91-2051-4505-9B6A-14170241E776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009149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7" Type="http://schemas.openxmlformats.org/officeDocument/2006/relationships/image" Target="../media/image6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wmf"/><Relationship Id="rId5" Type="http://schemas.openxmlformats.org/officeDocument/2006/relationships/image" Target="../media/image4.wmf"/><Relationship Id="rId4" Type="http://schemas.openxmlformats.org/officeDocument/2006/relationships/image" Target="../media/image3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wmf"/><Relationship Id="rId7" Type="http://schemas.openxmlformats.org/officeDocument/2006/relationships/image" Target="../media/image12.wmf"/><Relationship Id="rId2" Type="http://schemas.openxmlformats.org/officeDocument/2006/relationships/image" Target="../media/image7.w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wmf"/><Relationship Id="rId5" Type="http://schemas.openxmlformats.org/officeDocument/2006/relationships/image" Target="../media/image10.wmf"/><Relationship Id="rId4" Type="http://schemas.openxmlformats.org/officeDocument/2006/relationships/image" Target="../media/image9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wmf"/><Relationship Id="rId7" Type="http://schemas.openxmlformats.org/officeDocument/2006/relationships/image" Target="../media/image18.wmf"/><Relationship Id="rId2" Type="http://schemas.openxmlformats.org/officeDocument/2006/relationships/image" Target="../media/image13.w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wmf"/><Relationship Id="rId5" Type="http://schemas.openxmlformats.org/officeDocument/2006/relationships/image" Target="../media/image16.wmf"/><Relationship Id="rId4" Type="http://schemas.openxmlformats.org/officeDocument/2006/relationships/image" Target="../media/image15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wmf"/><Relationship Id="rId7" Type="http://schemas.openxmlformats.org/officeDocument/2006/relationships/image" Target="../media/image24.wmf"/><Relationship Id="rId2" Type="http://schemas.openxmlformats.org/officeDocument/2006/relationships/image" Target="../media/image19.w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wmf"/><Relationship Id="rId5" Type="http://schemas.openxmlformats.org/officeDocument/2006/relationships/image" Target="../media/image22.wmf"/><Relationship Id="rId4" Type="http://schemas.openxmlformats.org/officeDocument/2006/relationships/image" Target="../media/image21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wmf"/><Relationship Id="rId2" Type="http://schemas.openxmlformats.org/officeDocument/2006/relationships/image" Target="../media/image25.w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640" y="170904"/>
            <a:ext cx="3360742" cy="27449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1008" y="114832"/>
            <a:ext cx="3151995" cy="25744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3 CuadroTexto"/>
          <p:cNvSpPr txBox="1"/>
          <p:nvPr/>
        </p:nvSpPr>
        <p:spPr>
          <a:xfrm>
            <a:off x="2134284" y="267489"/>
            <a:ext cx="11507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000" b="1" dirty="0" smtClean="0"/>
              <a:t>I REGION</a:t>
            </a:r>
            <a:endParaRPr lang="es-CL" sz="2000" b="1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915816"/>
            <a:ext cx="3671030" cy="29983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7 CuadroTexto"/>
          <p:cNvSpPr txBox="1"/>
          <p:nvPr/>
        </p:nvSpPr>
        <p:spPr>
          <a:xfrm>
            <a:off x="2350308" y="3131840"/>
            <a:ext cx="12196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000" b="1" dirty="0" smtClean="0"/>
              <a:t>II REGION</a:t>
            </a:r>
            <a:endParaRPr lang="es-CL" sz="2000" b="1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1058" y="2918175"/>
            <a:ext cx="3298826" cy="26943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88" y="5898175"/>
            <a:ext cx="3850953" cy="31452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10 CuadroTexto"/>
          <p:cNvSpPr txBox="1"/>
          <p:nvPr/>
        </p:nvSpPr>
        <p:spPr>
          <a:xfrm>
            <a:off x="2281429" y="6084168"/>
            <a:ext cx="12885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000" b="1" dirty="0" smtClean="0"/>
              <a:t>III REGION</a:t>
            </a:r>
            <a:endParaRPr lang="es-CL" sz="2000" b="1" dirty="0"/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7925" y="6084168"/>
            <a:ext cx="3101959" cy="25335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482016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132950"/>
            <a:ext cx="3429002" cy="2800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3 CuadroTexto"/>
          <p:cNvSpPr txBox="1"/>
          <p:nvPr/>
        </p:nvSpPr>
        <p:spPr>
          <a:xfrm>
            <a:off x="1018544" y="132950"/>
            <a:ext cx="13029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000" b="1" dirty="0" smtClean="0"/>
              <a:t>IV REGION</a:t>
            </a:r>
            <a:endParaRPr lang="es-CL" sz="2000" b="1" dirty="0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3486" y="132950"/>
            <a:ext cx="3304513" cy="26989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413" y="3059275"/>
            <a:ext cx="3495676" cy="28551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7 CuadroTexto"/>
          <p:cNvSpPr txBox="1"/>
          <p:nvPr/>
        </p:nvSpPr>
        <p:spPr>
          <a:xfrm>
            <a:off x="1018544" y="3043135"/>
            <a:ext cx="12340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000" b="1" dirty="0" smtClean="0"/>
              <a:t>V REGION</a:t>
            </a:r>
            <a:endParaRPr lang="es-CL" sz="2000" b="1" dirty="0"/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3487" y="3043135"/>
            <a:ext cx="3251965" cy="2656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895" y="5880440"/>
            <a:ext cx="3635884" cy="29696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11 CuadroTexto"/>
          <p:cNvSpPr txBox="1"/>
          <p:nvPr/>
        </p:nvSpPr>
        <p:spPr>
          <a:xfrm>
            <a:off x="1018544" y="5837618"/>
            <a:ext cx="19553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000" b="1" dirty="0" err="1" smtClean="0"/>
              <a:t>Metrop</a:t>
            </a:r>
            <a:r>
              <a:rPr lang="es-CL" sz="2000" b="1" dirty="0" smtClean="0"/>
              <a:t>. REGION</a:t>
            </a:r>
            <a:endParaRPr lang="es-CL" sz="2000" b="1" dirty="0"/>
          </a:p>
        </p:txBody>
      </p:sp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9659" y="5914394"/>
            <a:ext cx="3178340" cy="25959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02383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61620"/>
            <a:ext cx="3593040" cy="29346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1 CuadroTexto"/>
          <p:cNvSpPr txBox="1"/>
          <p:nvPr/>
        </p:nvSpPr>
        <p:spPr>
          <a:xfrm>
            <a:off x="1268759" y="179512"/>
            <a:ext cx="13029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000" b="1" dirty="0" smtClean="0"/>
              <a:t>VI REGION</a:t>
            </a:r>
            <a:endParaRPr lang="es-CL" sz="2000" b="1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5108" y="-7535"/>
            <a:ext cx="3402891" cy="27793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169" y="3096262"/>
            <a:ext cx="3696164" cy="30188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3040" y="3147962"/>
            <a:ext cx="3156846" cy="25783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6 CuadroTexto"/>
          <p:cNvSpPr txBox="1"/>
          <p:nvPr/>
        </p:nvSpPr>
        <p:spPr>
          <a:xfrm>
            <a:off x="1796520" y="3116453"/>
            <a:ext cx="13719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000" b="1" dirty="0" smtClean="0"/>
              <a:t>VII REGION</a:t>
            </a:r>
            <a:endParaRPr lang="es-CL" sz="2000" b="1" dirty="0"/>
          </a:p>
        </p:txBody>
      </p:sp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169" y="6012160"/>
            <a:ext cx="3659808" cy="2989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8 CuadroTexto"/>
          <p:cNvSpPr txBox="1"/>
          <p:nvPr/>
        </p:nvSpPr>
        <p:spPr>
          <a:xfrm>
            <a:off x="1920251" y="6023523"/>
            <a:ext cx="14408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000" b="1" dirty="0" smtClean="0"/>
              <a:t>VIII REGION</a:t>
            </a:r>
            <a:endParaRPr lang="es-CL" sz="2000" b="1" dirty="0"/>
          </a:p>
        </p:txBody>
      </p:sp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5900" y="6027159"/>
            <a:ext cx="3311617" cy="27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035776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4030" y="0"/>
            <a:ext cx="3803070" cy="31061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1 CuadroTexto"/>
          <p:cNvSpPr txBox="1"/>
          <p:nvPr/>
        </p:nvSpPr>
        <p:spPr>
          <a:xfrm>
            <a:off x="1887505" y="251520"/>
            <a:ext cx="12917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000" b="1" dirty="0" smtClean="0"/>
              <a:t>IX REGION</a:t>
            </a:r>
            <a:endParaRPr lang="es-CL" sz="2000" b="1" dirty="0"/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3334" y="21152"/>
            <a:ext cx="3214666" cy="26256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429" y="2915816"/>
            <a:ext cx="3726611" cy="3043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5 CuadroTexto"/>
          <p:cNvSpPr txBox="1"/>
          <p:nvPr/>
        </p:nvSpPr>
        <p:spPr>
          <a:xfrm>
            <a:off x="1887505" y="3106185"/>
            <a:ext cx="12228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000" b="1" dirty="0" smtClean="0"/>
              <a:t>X REGION</a:t>
            </a:r>
            <a:endParaRPr lang="es-CL" sz="2000" b="1" dirty="0"/>
          </a:p>
        </p:txBody>
      </p:sp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8276" y="2915816"/>
            <a:ext cx="3239724" cy="26460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429" y="5771260"/>
            <a:ext cx="3751174" cy="30637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8 CuadroTexto"/>
          <p:cNvSpPr txBox="1"/>
          <p:nvPr/>
        </p:nvSpPr>
        <p:spPr>
          <a:xfrm>
            <a:off x="2039904" y="5977901"/>
            <a:ext cx="12917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000" b="1" dirty="0" smtClean="0"/>
              <a:t>XI REGION</a:t>
            </a:r>
            <a:endParaRPr lang="es-CL" sz="2000" b="1" dirty="0"/>
          </a:p>
        </p:txBody>
      </p:sp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3334" y="5793604"/>
            <a:ext cx="3214666" cy="26256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371247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67544"/>
            <a:ext cx="3582867" cy="29263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1 CuadroTexto"/>
          <p:cNvSpPr txBox="1"/>
          <p:nvPr/>
        </p:nvSpPr>
        <p:spPr>
          <a:xfrm>
            <a:off x="1052736" y="334534"/>
            <a:ext cx="136069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000" b="1" dirty="0" smtClean="0"/>
              <a:t>XII REGION</a:t>
            </a:r>
            <a:endParaRPr lang="es-CL" sz="2000" b="1" dirty="0"/>
          </a:p>
        </p:txBody>
      </p:sp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6992" y="323528"/>
            <a:ext cx="3501008" cy="28594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188305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</TotalTime>
  <Words>27</Words>
  <Application>Microsoft Office PowerPoint</Application>
  <PresentationFormat>Presentación en pantalla (4:3)</PresentationFormat>
  <Paragraphs>13</Paragraphs>
  <Slides>5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6" baseType="lpstr"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uricio Lima</dc:creator>
  <cp:lastModifiedBy>m</cp:lastModifiedBy>
  <cp:revision>8</cp:revision>
  <dcterms:created xsi:type="dcterms:W3CDTF">2012-07-04T00:33:32Z</dcterms:created>
  <dcterms:modified xsi:type="dcterms:W3CDTF">2012-12-10T18:19:44Z</dcterms:modified>
</cp:coreProperties>
</file>